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43" autoAdjust="0"/>
    <p:restoredTop sz="94660"/>
  </p:normalViewPr>
  <p:slideViewPr>
    <p:cSldViewPr snapToGrid="0">
      <p:cViewPr varScale="1">
        <p:scale>
          <a:sx n="59" d="100"/>
          <a:sy n="59" d="100"/>
        </p:scale>
        <p:origin x="2189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BD01C-7368-460C-B6EF-0BEE0E569F21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1A36E-50AC-4D05-9C9E-DBC9C22A2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05001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BD01C-7368-460C-B6EF-0BEE0E569F21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1A36E-50AC-4D05-9C9E-DBC9C22A2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59228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BD01C-7368-460C-B6EF-0BEE0E569F21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1A36E-50AC-4D05-9C9E-DBC9C22A2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32300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BD01C-7368-460C-B6EF-0BEE0E569F21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1A36E-50AC-4D05-9C9E-DBC9C22A2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37297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BD01C-7368-460C-B6EF-0BEE0E569F21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1A36E-50AC-4D05-9C9E-DBC9C22A2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94210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BD01C-7368-460C-B6EF-0BEE0E569F21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1A36E-50AC-4D05-9C9E-DBC9C22A2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96508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BD01C-7368-460C-B6EF-0BEE0E569F21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1A36E-50AC-4D05-9C9E-DBC9C22A2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65123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BD01C-7368-460C-B6EF-0BEE0E569F21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1A36E-50AC-4D05-9C9E-DBC9C22A2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75366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BD01C-7368-460C-B6EF-0BEE0E569F21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1A36E-50AC-4D05-9C9E-DBC9C22A2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61937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BD01C-7368-460C-B6EF-0BEE0E569F21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1A36E-50AC-4D05-9C9E-DBC9C22A2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11431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BD01C-7368-460C-B6EF-0BEE0E569F21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1A36E-50AC-4D05-9C9E-DBC9C22A2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26361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5BD01C-7368-460C-B6EF-0BEE0E569F21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A1A36E-50AC-4D05-9C9E-DBC9C22A2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154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Rectangle 46"/>
          <p:cNvSpPr/>
          <p:nvPr/>
        </p:nvSpPr>
        <p:spPr>
          <a:xfrm>
            <a:off x="0" y="1879131"/>
            <a:ext cx="5922584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. Figure 3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representative calibration curve of G6-Cy5 (left) and G4-Cy3 (right). This calibration curve demonstrates G4-Cy5 is two folds brighter than G6-Cy5. The calibration curve was generated using a Shimadzu RF-5301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ectrofluorophotomete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wavelengths used for the Cy3-labelled dendrimers are excitation 554 nm and emission 568 nm. The wavelengths used for the Cy5-labelled dendrimers are excitation 645 nm and emission 662 nm. The calibration curve is generated in methanol under excitation slit width 5 and emission slit width 5.</a:t>
            </a:r>
            <a:endParaRPr 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C7FB9D78-3A8A-4496-9865-701C61F28EB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5944115" cy="18106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356865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92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Johns Hopkin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vin Liaw</dc:creator>
  <cp:lastModifiedBy>Kevin Liaw</cp:lastModifiedBy>
  <cp:revision>4</cp:revision>
  <dcterms:created xsi:type="dcterms:W3CDTF">2020-02-07T23:45:21Z</dcterms:created>
  <dcterms:modified xsi:type="dcterms:W3CDTF">2020-03-24T22:34:22Z</dcterms:modified>
</cp:coreProperties>
</file>